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58400" cy="7772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415E6-E9A9-4264-A98E-8A9CC26FE2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15679-AEEE-406C-9245-DB5B64A290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81CB1-9DEC-4939-8EFA-52F4D823A3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A6592-81D2-435E-BA81-23246DA31A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A7778-D98E-49EC-BCAF-610C0E6B15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4CEC9-516F-4947-A869-6479052723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36474-83B9-48CA-8AD0-50A70D4B12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DEC9B-F8D4-4ACB-BEA1-E9E898509A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33983-E306-4740-AAC9-9AC92B204E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A6E31-2A1C-4EA7-8CA4-CB108FE3C6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5D80B-64FC-4F75-980A-8CCDFA1E99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3A30C-23E0-4976-9316-C8A3E4E6B2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DAC56A-0205-4BD0-A23B-A2F76913C000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55680" y="279360"/>
            <a:ext cx="9360000" cy="58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Figure 3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mino acid sequence alignment of Cucumis melo CmCAD5 (MELO3C023272P1a) with closely related sequences of other plants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569360" y="7188120"/>
            <a:ext cx="2425680" cy="52092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1447920" y="838080"/>
            <a:ext cx="6263640" cy="2861280"/>
            <a:chOff x="1447920" y="838080"/>
            <a:chExt cx="6263640" cy="2861280"/>
          </a:xfrm>
        </p:grpSpPr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506960" y="1035360"/>
              <a:ext cx="6144120" cy="1177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1447920" y="2246760"/>
              <a:ext cx="6143400" cy="117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3906720" y="2279520"/>
              <a:ext cx="233280" cy="19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7600" rIns="57600" tIns="28800" bIns="28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081680" y="2279520"/>
              <a:ext cx="233280" cy="19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7600" rIns="57600" tIns="28800" bIns="28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673440" y="2279520"/>
              <a:ext cx="233280" cy="19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7600" rIns="57600" tIns="28800" bIns="28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609800" y="2279520"/>
              <a:ext cx="233280" cy="19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7600" rIns="57600" tIns="28800" bIns="28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368680" y="1002240"/>
              <a:ext cx="193680" cy="38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1560" rIns="61560" tIns="30600" bIns="306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832440" y="1002240"/>
              <a:ext cx="193320" cy="38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1560" rIns="61560" tIns="30600" bIns="306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389920" y="838080"/>
              <a:ext cx="20232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160" rIns="74160" tIns="37080" bIns="3708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449680" y="939600"/>
              <a:ext cx="20232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160" rIns="74160" tIns="37080" bIns="3708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506920" y="939600"/>
              <a:ext cx="20232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160" rIns="74160" tIns="37080" bIns="3708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681880" y="939600"/>
              <a:ext cx="202320" cy="18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160" rIns="74160" tIns="37080" bIns="3708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386680" y="2179440"/>
              <a:ext cx="14832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760" bIns="23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504040" y="2179440"/>
              <a:ext cx="14832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760" bIns="23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850080" y="2214720"/>
              <a:ext cx="14832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760" bIns="23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397680" y="3422880"/>
              <a:ext cx="14832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760" bIns="23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832440" y="1068840"/>
              <a:ext cx="468000" cy="121104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916640" y="2280240"/>
              <a:ext cx="468000" cy="117756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970000" y="2280240"/>
              <a:ext cx="1815120" cy="124452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541920" y="2241360"/>
              <a:ext cx="116964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160" rIns="74160" tIns="37080" bIns="37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506240" y="3487680"/>
              <a:ext cx="117180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160" rIns="74160" tIns="37080" bIns="370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1295280" y="3505320"/>
            <a:ext cx="6264360" cy="2696760"/>
            <a:chOff x="1295280" y="3505320"/>
            <a:chExt cx="6264360" cy="2696760"/>
          </a:xfrm>
        </p:grpSpPr>
        <p:pic>
          <p:nvPicPr>
            <p:cNvPr id="66" name="" descr=""/>
            <p:cNvPicPr/>
            <p:nvPr/>
          </p:nvPicPr>
          <p:blipFill>
            <a:blip r:embed="rId4"/>
            <a:stretch/>
          </p:blipFill>
          <p:spPr>
            <a:xfrm>
              <a:off x="1355040" y="3703320"/>
              <a:ext cx="6204600" cy="118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" descr=""/>
            <p:cNvPicPr/>
            <p:nvPr/>
          </p:nvPicPr>
          <p:blipFill>
            <a:blip r:embed="rId5"/>
            <a:stretch/>
          </p:blipFill>
          <p:spPr>
            <a:xfrm>
              <a:off x="1295280" y="4891680"/>
              <a:ext cx="6204600" cy="118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"/>
            <p:cNvSpPr/>
            <p:nvPr/>
          </p:nvSpPr>
          <p:spPr>
            <a:xfrm>
              <a:off x="2773080" y="3664440"/>
              <a:ext cx="195480" cy="3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2280" rIns="62280" tIns="30960" bIns="3096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793600" y="35053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031560" y="360648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50936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62564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56660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74444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80312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86360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10344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16392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398640" y="3571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202840" y="479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504240" y="479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561840" y="479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739320" y="479592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098320" y="47624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158800" y="47624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675120" y="4911480"/>
              <a:ext cx="24444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6754320" y="47624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6813000" y="47624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790000" y="489240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6868800" y="604692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547160" y="3737160"/>
              <a:ext cx="472680" cy="115452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073400" y="4892400"/>
              <a:ext cx="1300320" cy="37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880" rIns="74880" tIns="37440" bIns="37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NADPH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3" name="" descr=""/>
          <p:cNvPicPr/>
          <p:nvPr/>
        </p:nvPicPr>
        <p:blipFill>
          <a:blip r:embed="rId6"/>
          <a:stretch/>
        </p:blipFill>
        <p:spPr>
          <a:xfrm>
            <a:off x="1219320" y="6172200"/>
            <a:ext cx="6399000" cy="1206360"/>
          </a:xfrm>
          <a:prstGeom prst="rect">
            <a:avLst/>
          </a:prstGeom>
          <a:ln w="0">
            <a:noFill/>
          </a:ln>
        </p:spPr>
      </p:pic>
      <p:sp>
        <p:nvSpPr>
          <p:cNvPr id="94" name=""/>
          <p:cNvSpPr/>
          <p:nvPr/>
        </p:nvSpPr>
        <p:spPr>
          <a:xfrm>
            <a:off x="-628560" y="92948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-628560" y="103712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30360" y="-259884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630360" y="195588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630360" y="625140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30360" y="834876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32160" y="8462160"/>
            <a:ext cx="8118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900"/>
            </a:b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Figure.S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C SYSTEM</cp:lastModifiedBy>
  <dcterms:modified xsi:type="dcterms:W3CDTF">2014-01-28T03:55:22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